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  <p:sldId id="261" r:id="rId3"/>
    <p:sldId id="257" r:id="rId4"/>
    <p:sldId id="256" r:id="rId5"/>
    <p:sldId id="258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56"/>
  </p:normalViewPr>
  <p:slideViewPr>
    <p:cSldViewPr snapToGrid="0" snapToObjects="1">
      <p:cViewPr varScale="1">
        <p:scale>
          <a:sx n="62" d="100"/>
          <a:sy n="62" d="100"/>
        </p:scale>
        <p:origin x="80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FE2F9A-DF54-E143-9831-635F1D424F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990BFE6-CE72-CD4E-9158-2886EF6314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CBE03F-58FF-D346-AF6F-543BDC0AE5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6E4F8-4208-8348-8693-1CF4383A8443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5019ED-8E1A-ED45-B3C4-C6F35B2E5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3A9CD9-33B9-9749-8904-A52FD559BC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66122-C893-0546-A2DE-A03E3E957D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159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D02626-B5F8-CB43-BBE8-86D592916A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4DE033-4859-1742-8B59-7309BE6CEC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C7ABF0-C407-764F-93AA-00AB4FEE9B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6E4F8-4208-8348-8693-1CF4383A8443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30D19C-4AF0-624E-996D-046EFDD7E0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0835DD-465C-1046-941C-615063748F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66122-C893-0546-A2DE-A03E3E957D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1357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A205337-8BC8-2145-B324-F7B672FD9C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7F6B984-BAD3-D946-A4DF-6546E1E116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F1019E-C9B2-A342-8B8E-131E820A81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6E4F8-4208-8348-8693-1CF4383A8443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1B9AA2-98D5-A349-A1EE-4DA588DADB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D8ADFF-E0C2-864B-BDFE-A65716FA1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66122-C893-0546-A2DE-A03E3E957D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593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4F689F-810D-E14C-B2C7-6A1268906D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42C10A-016E-8142-A542-0F83B99D98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98FDE3-DD4F-E048-BC68-154B616D62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6E4F8-4208-8348-8693-1CF4383A8443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A8982E-A1A8-0A44-8F8F-5FF734A5E5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C5F7AF-2752-3A4C-958A-5E8ACCAC57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66122-C893-0546-A2DE-A03E3E957D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335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E38582-7B5C-1B48-9597-443BDFA419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DDFDD8-E4E4-3C47-B573-76CFBDF507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69087E-E31F-4648-AC55-477BAF45F7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6E4F8-4208-8348-8693-1CF4383A8443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D9AE35-26E9-7940-ABD6-1EF76CF9C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60A3CC-0554-3241-8EC9-62833415FB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66122-C893-0546-A2DE-A03E3E957D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6422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CB802F-1D0D-CA40-925E-A082632373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EBB9BB-502A-C649-A04E-B83078101E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5AA6B3-7877-CE44-9F44-D2E84C25E1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4C63949-1D32-5145-884C-BEDE920380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6E4F8-4208-8348-8693-1CF4383A8443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0420B4-E3EB-3B43-A8B5-AB02B0907B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277428-416F-DC40-8154-27A2BC6F3B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66122-C893-0546-A2DE-A03E3E957D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339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3E5576-2B6B-2E40-9BF7-2B075AD8EA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62EEFE-CC69-B24D-A7E0-D64D769077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8AA57FB-38A2-8141-8434-682FE50D66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B8FADCB-F12A-AC4D-8A20-6AC8AB5F6E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538C833-5146-8444-984B-5F5F66EE25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CC52698-DCF0-B54D-BE5A-5FB57EAFE3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6E4F8-4208-8348-8693-1CF4383A8443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248FA06-2EED-6344-8DC8-071EF5C590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0C10115-880E-3E48-B502-D6D97DF88F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66122-C893-0546-A2DE-A03E3E957D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533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6B3AC9-96D6-5C4A-9293-BF37A4EE0F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451A412-40C9-144E-9093-6057F2F4BB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6E4F8-4208-8348-8693-1CF4383A8443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6858032-9440-0743-96FC-E090E13D66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02BF1DA-9A38-FB48-9CC1-29BD52D87B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66122-C893-0546-A2DE-A03E3E957D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2233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DBF0198-25A2-774B-83A9-0B62FBCA94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6E4F8-4208-8348-8693-1CF4383A8443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0C0330D-7B8D-0A43-AAC4-B4CB53B3A4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AB4A553-57BA-AB44-B611-554A7C6DAB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66122-C893-0546-A2DE-A03E3E957D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0905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5C40F7-F5D6-2F44-BD05-42CEBFC7B5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9088B9-59CB-9B4A-8EE8-6819EBE6D7A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1C6933F-909B-0D4A-B766-0404C73641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A307B2-56E5-7347-AB5E-74DB5E8010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6E4F8-4208-8348-8693-1CF4383A8443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A4C7107-BAD5-C94D-8E0F-AFE2F725EA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7BB1D2-F62D-4241-8AFB-C7D7F6F71B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66122-C893-0546-A2DE-A03E3E957D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016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3634ED-A084-2D4D-B995-45CA275596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9F5C046-0389-FB4D-91C5-25910D2CDA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35C1DE2-7003-1B46-ACF6-07B26F0517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9B030B-21D9-784A-BB34-D4D3086995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6E4F8-4208-8348-8693-1CF4383A8443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84C5BD-8383-CE47-9BED-F38D1127F1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FED9C9-EDC1-6D4F-ADD4-304677EA41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66122-C893-0546-A2DE-A03E3E957D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68753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34CDBC3-37CB-3D4C-82FD-C38D76741E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D2C54A-EBEC-E141-B950-07E04984FB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6709B1-39C4-414E-AACA-4763CAA92B4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86E4F8-4208-8348-8693-1CF4383A8443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E5F685-A892-5D45-917E-1943FF6BF35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7CDC41-4DB8-0F49-BB6C-273E2120E05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566122-C893-0546-A2DE-A03E3E957D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6863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1C5F938A-3789-EC47-BF1F-C0BB24D7C67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9145" y="934852"/>
            <a:ext cx="3568700" cy="548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E57EC5B5-5619-E743-A751-051F588FE45D}"/>
              </a:ext>
            </a:extLst>
          </p:cNvPr>
          <p:cNvSpPr txBox="1">
            <a:spLocks noChangeArrowheads="1"/>
          </p:cNvSpPr>
          <p:nvPr/>
        </p:nvSpPr>
        <p:spPr>
          <a:xfrm>
            <a:off x="1056245" y="350652"/>
            <a:ext cx="9359900" cy="457200"/>
          </a:xfrm>
          <a:prstGeom prst="rect">
            <a:avLst/>
          </a:prstGeom>
          <a:noFill/>
          <a:ln/>
        </p:spPr>
        <p:txBody>
          <a:bodyPr vert="horz" lIns="91440" tIns="45720" rIns="91440" bIns="45720" rtlCol="0">
            <a:sp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spcBef>
                <a:spcPct val="0"/>
              </a:spcBef>
              <a:buFontTx/>
              <a:buNone/>
            </a:pPr>
            <a:r>
              <a:rPr lang="en-US" altLang="en-US" sz="1600" b="1">
                <a:solidFill>
                  <a:schemeClr val="tx2"/>
                </a:solidFill>
              </a:rPr>
              <a:t>Figure 4. Competition between TCF and SATB1 for recruitment of β-catenin affects the TCF mediated transcription regulation.</a:t>
            </a:r>
            <a:endParaRPr lang="en-US" altLang="en-US" sz="1600" b="1" dirty="0">
              <a:solidFill>
                <a:schemeClr val="tx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561570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B6417D8-EB88-B54B-A51A-20CF2FF946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53922" y="997527"/>
            <a:ext cx="5703351" cy="3770416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71401685-211E-FD4B-951E-BFA1224BB6A8}"/>
              </a:ext>
            </a:extLst>
          </p:cNvPr>
          <p:cNvSpPr/>
          <p:nvPr/>
        </p:nvSpPr>
        <p:spPr>
          <a:xfrm>
            <a:off x="7920842" y="2090057"/>
            <a:ext cx="1353787" cy="17219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4D85434-A9B8-C748-8A6A-91C8073FCA60}"/>
              </a:ext>
            </a:extLst>
          </p:cNvPr>
          <p:cNvSpPr txBox="1"/>
          <p:nvPr/>
        </p:nvSpPr>
        <p:spPr>
          <a:xfrm>
            <a:off x="531124" y="65760"/>
            <a:ext cx="13620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Figure 4A</a:t>
            </a:r>
          </a:p>
        </p:txBody>
      </p:sp>
      <p:pic>
        <p:nvPicPr>
          <p:cNvPr id="8" name="Picture 2">
            <a:extLst>
              <a:ext uri="{FF2B5EF4-FFF2-40B4-BE49-F238E27FC236}">
                <a16:creationId xmlns:a16="http://schemas.microsoft.com/office/drawing/2014/main" id="{2B01CC89-C4C8-E347-8021-9552196BCF3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321" b="72100"/>
          <a:stretch/>
        </p:blipFill>
        <p:spPr bwMode="auto">
          <a:xfrm>
            <a:off x="554677" y="1414360"/>
            <a:ext cx="3505896" cy="30270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56CAA7C8-3F27-3B42-B4DF-121931026A2B}"/>
              </a:ext>
            </a:extLst>
          </p:cNvPr>
          <p:cNvCxnSpPr/>
          <p:nvPr/>
        </p:nvCxnSpPr>
        <p:spPr>
          <a:xfrm flipV="1">
            <a:off x="3194462" y="2707574"/>
            <a:ext cx="4726380" cy="57001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067681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71BF2A9-EE60-D441-AE8B-2A78075A38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6157101" y="1775079"/>
            <a:ext cx="5731701" cy="368466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5D7198A-CF5A-9A48-8854-6A8F8F415DF6}"/>
              </a:ext>
            </a:extLst>
          </p:cNvPr>
          <p:cNvSpPr txBox="1"/>
          <p:nvPr/>
        </p:nvSpPr>
        <p:spPr>
          <a:xfrm>
            <a:off x="814192" y="325677"/>
            <a:ext cx="206107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4A lower panel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D72B8868-C566-1448-9941-43F2301E6207}"/>
              </a:ext>
            </a:extLst>
          </p:cNvPr>
          <p:cNvSpPr/>
          <p:nvPr/>
        </p:nvSpPr>
        <p:spPr>
          <a:xfrm>
            <a:off x="7180619" y="1778696"/>
            <a:ext cx="2702417" cy="23173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8" name="Picture 2">
            <a:extLst>
              <a:ext uri="{FF2B5EF4-FFF2-40B4-BE49-F238E27FC236}">
                <a16:creationId xmlns:a16="http://schemas.microsoft.com/office/drawing/2014/main" id="{07DAB84F-5E9A-4E4D-81D3-F5A1275996F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4038" b="49550"/>
          <a:stretch/>
        </p:blipFill>
        <p:spPr bwMode="auto">
          <a:xfrm>
            <a:off x="2409757" y="1153180"/>
            <a:ext cx="1640245" cy="27678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30A614F3-8D95-004A-96D3-E0BA751B6328}"/>
              </a:ext>
            </a:extLst>
          </p:cNvPr>
          <p:cNvCxnSpPr/>
          <p:nvPr/>
        </p:nvCxnSpPr>
        <p:spPr>
          <a:xfrm flipV="1">
            <a:off x="3797085" y="2537125"/>
            <a:ext cx="3383534" cy="77951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607271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237DFFA-9DE0-974F-832A-D6A8D1E1F92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5483"/>
          <a:stretch/>
        </p:blipFill>
        <p:spPr>
          <a:xfrm rot="16200000">
            <a:off x="7266344" y="-351641"/>
            <a:ext cx="3658371" cy="4738531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248B3CC8-9FF2-194B-AE7B-2B19F94D7EC0}"/>
              </a:ext>
            </a:extLst>
          </p:cNvPr>
          <p:cNvSpPr/>
          <p:nvPr/>
        </p:nvSpPr>
        <p:spPr>
          <a:xfrm>
            <a:off x="7629244" y="1426774"/>
            <a:ext cx="975852" cy="9478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AA8B2F51-C4CA-B646-B481-4ECF00CBCEDF}"/>
              </a:ext>
            </a:extLst>
          </p:cNvPr>
          <p:cNvSpPr/>
          <p:nvPr/>
        </p:nvSpPr>
        <p:spPr>
          <a:xfrm>
            <a:off x="8610859" y="1426774"/>
            <a:ext cx="2388106" cy="9478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84B6D69-8D75-9E45-8B6C-EB778BCA5B4A}"/>
              </a:ext>
            </a:extLst>
          </p:cNvPr>
          <p:cNvSpPr txBox="1"/>
          <p:nvPr/>
        </p:nvSpPr>
        <p:spPr>
          <a:xfrm>
            <a:off x="449961" y="188440"/>
            <a:ext cx="13508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Figure 4B</a:t>
            </a:r>
          </a:p>
        </p:txBody>
      </p:sp>
      <p:pic>
        <p:nvPicPr>
          <p:cNvPr id="9" name="Picture 2">
            <a:extLst>
              <a:ext uri="{FF2B5EF4-FFF2-40B4-BE49-F238E27FC236}">
                <a16:creationId xmlns:a16="http://schemas.microsoft.com/office/drawing/2014/main" id="{D8B0BF79-00A2-404E-AA0B-9936CD893B4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208" b="77212"/>
          <a:stretch/>
        </p:blipFill>
        <p:spPr bwMode="auto">
          <a:xfrm>
            <a:off x="925723" y="1443311"/>
            <a:ext cx="4206347" cy="23847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2FBD0E3-80E2-C54D-AF3F-FCE81DEF2D0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5483"/>
          <a:stretch/>
        </p:blipFill>
        <p:spPr>
          <a:xfrm rot="16200000" flipV="1">
            <a:off x="7946735" y="2951801"/>
            <a:ext cx="2817461" cy="4607477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1C6C0D54-F2FE-E746-872B-3AAB81A30788}"/>
              </a:ext>
            </a:extLst>
          </p:cNvPr>
          <p:cNvSpPr/>
          <p:nvPr/>
        </p:nvSpPr>
        <p:spPr>
          <a:xfrm>
            <a:off x="7501180" y="4664990"/>
            <a:ext cx="2324745" cy="9608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F088E7F1-1DA7-F648-84C2-232F1A891BA2}"/>
              </a:ext>
            </a:extLst>
          </p:cNvPr>
          <p:cNvSpPr/>
          <p:nvPr/>
        </p:nvSpPr>
        <p:spPr>
          <a:xfrm>
            <a:off x="9825925" y="4664990"/>
            <a:ext cx="960895" cy="9608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3C139F40-64DA-3C43-A668-2083D7A75FEC}"/>
              </a:ext>
            </a:extLst>
          </p:cNvPr>
          <p:cNvCxnSpPr/>
          <p:nvPr/>
        </p:nvCxnSpPr>
        <p:spPr>
          <a:xfrm>
            <a:off x="4804475" y="3580108"/>
            <a:ext cx="5408908" cy="94539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EB1662FE-8B8C-BB4E-B5B4-9CC0F94D1A3D}"/>
              </a:ext>
            </a:extLst>
          </p:cNvPr>
          <p:cNvCxnSpPr>
            <a:cxnSpLocks/>
          </p:cNvCxnSpPr>
          <p:nvPr/>
        </p:nvCxnSpPr>
        <p:spPr>
          <a:xfrm>
            <a:off x="2129477" y="3626602"/>
            <a:ext cx="5371703" cy="115624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84826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09046BB-80FE-F344-9904-CC04AE48E46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48482"/>
          <a:stretch/>
        </p:blipFill>
        <p:spPr>
          <a:xfrm>
            <a:off x="6488835" y="0"/>
            <a:ext cx="2266857" cy="685800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63FB87B7-8CDC-1341-A0B1-5DBF1CE317ED}"/>
              </a:ext>
            </a:extLst>
          </p:cNvPr>
          <p:cNvSpPr/>
          <p:nvPr/>
        </p:nvSpPr>
        <p:spPr>
          <a:xfrm>
            <a:off x="7139836" y="1478071"/>
            <a:ext cx="826717" cy="15782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EC5E614-65FC-594D-9EB3-2C501DE4923D}"/>
              </a:ext>
            </a:extLst>
          </p:cNvPr>
          <p:cNvSpPr txBox="1"/>
          <p:nvPr/>
        </p:nvSpPr>
        <p:spPr>
          <a:xfrm>
            <a:off x="1152395" y="663879"/>
            <a:ext cx="134761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Figure 4C</a:t>
            </a:r>
          </a:p>
        </p:txBody>
      </p:sp>
      <p:pic>
        <p:nvPicPr>
          <p:cNvPr id="8" name="Picture 2">
            <a:extLst>
              <a:ext uri="{FF2B5EF4-FFF2-40B4-BE49-F238E27FC236}">
                <a16:creationId xmlns:a16="http://schemas.microsoft.com/office/drawing/2014/main" id="{A1C56A70-2E6E-4C4E-91C8-7D1E3E5E83A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789" r="52445"/>
          <a:stretch/>
        </p:blipFill>
        <p:spPr bwMode="auto">
          <a:xfrm>
            <a:off x="1960514" y="2106482"/>
            <a:ext cx="1697085" cy="26450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6F0BE05F-F417-3B46-8A35-432A274F0A0E}"/>
              </a:ext>
            </a:extLst>
          </p:cNvPr>
          <p:cNvCxnSpPr>
            <a:cxnSpLocks/>
          </p:cNvCxnSpPr>
          <p:nvPr/>
        </p:nvCxnSpPr>
        <p:spPr>
          <a:xfrm>
            <a:off x="3332099" y="3056352"/>
            <a:ext cx="3519963" cy="201441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 3">
            <a:extLst>
              <a:ext uri="{FF2B5EF4-FFF2-40B4-BE49-F238E27FC236}">
                <a16:creationId xmlns:a16="http://schemas.microsoft.com/office/drawing/2014/main" id="{3132DF00-AF78-5A46-ACEE-E3D9A7887578}"/>
              </a:ext>
            </a:extLst>
          </p:cNvPr>
          <p:cNvSpPr/>
          <p:nvPr/>
        </p:nvSpPr>
        <p:spPr>
          <a:xfrm>
            <a:off x="6958940" y="4476997"/>
            <a:ext cx="831273" cy="160316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8134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Widescreen</PresentationFormat>
  <Paragraphs>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mple Notani</dc:creator>
  <cp:lastModifiedBy>Alice Coles-Aldridge</cp:lastModifiedBy>
  <cp:revision>14</cp:revision>
  <dcterms:created xsi:type="dcterms:W3CDTF">2021-12-03T08:33:56Z</dcterms:created>
  <dcterms:modified xsi:type="dcterms:W3CDTF">2022-06-09T14:00:14Z</dcterms:modified>
</cp:coreProperties>
</file>